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5" r:id="rId3"/>
    <p:sldId id="266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riam Lenk" initials="ML" lastIdx="1" clrIdx="0">
    <p:extLst>
      <p:ext uri="{19B8F6BF-5375-455C-9EA6-DF929625EA0E}">
        <p15:presenceInfo xmlns:p15="http://schemas.microsoft.com/office/powerpoint/2012/main" userId="S-1-5-21-3915969816-2417712393-3077667278-452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505E3EF-67EA-436B-97B2-0124C06EBD24}" styleName="Mittlere Formatvorlage 4 - Akz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241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00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8135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8008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793814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MLL Aufzählung weis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A98DD-BBBF-4243-9962-C948A14AFE6D}" type="datetime1">
              <a:rPr lang="de-DE" smtClean="0"/>
              <a:t>20.08.2025</a:t>
            </a:fld>
            <a:endParaRPr lang="de-DE"/>
          </a:p>
          <a:p>
            <a:r>
              <a:rPr lang="de-DE"/>
              <a:t>MLL Münchner Leukämielabor GmbH</a:t>
            </a:r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 dirty="0"/>
              <a:t>Thema</a:t>
            </a:r>
          </a:p>
          <a:p>
            <a:r>
              <a:rPr lang="de-DE" dirty="0"/>
              <a:t>Sprecher</a:t>
            </a: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157AD1-C98B-DC4E-819C-D2C99B9D4E01}" type="slidenum">
              <a:rPr lang="de-DE" smtClean="0"/>
              <a:pPr/>
              <a:t>‹Nr.›</a:t>
            </a:fld>
            <a:endParaRPr lang="de-DE"/>
          </a:p>
        </p:txBody>
      </p:sp>
      <p:sp>
        <p:nvSpPr>
          <p:cNvPr id="8" name="Textplatzhalter 3"/>
          <p:cNvSpPr>
            <a:spLocks noGrp="1"/>
          </p:cNvSpPr>
          <p:nvPr>
            <p:ph type="body" sz="half" idx="21" hasCustomPrompt="1"/>
          </p:nvPr>
        </p:nvSpPr>
        <p:spPr>
          <a:xfrm>
            <a:off x="378000" y="334337"/>
            <a:ext cx="10080000" cy="551750"/>
          </a:xfrm>
        </p:spPr>
        <p:txBody>
          <a:bodyPr vert="horz" lIns="0" tIns="0" rIns="0" bIns="0" anchor="t" anchorCtr="0">
            <a:noAutofit/>
          </a:bodyPr>
          <a:lstStyle>
            <a:lvl1pPr marL="0" marR="0" indent="0" algn="l" defTabSz="914400" rtl="0" eaLnBrk="1" fontAlgn="auto" latinLnBrk="0" hangingPunct="1">
              <a:lnSpc>
                <a:spcPts val="22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 sz="2000" baseline="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dirty="0"/>
              <a:t>Überschrift 1 </a:t>
            </a:r>
          </a:p>
          <a:p>
            <a:pPr lvl="0"/>
            <a:r>
              <a:rPr lang="de-DE" dirty="0"/>
              <a:t>Überschrift 2</a:t>
            </a:r>
          </a:p>
          <a:p>
            <a:pPr lvl="0"/>
            <a:endParaRPr lang="de-DE" dirty="0"/>
          </a:p>
        </p:txBody>
      </p:sp>
      <p:sp>
        <p:nvSpPr>
          <p:cNvPr id="3" name="Textplatzhalter 2"/>
          <p:cNvSpPr>
            <a:spLocks noGrp="1"/>
          </p:cNvSpPr>
          <p:nvPr>
            <p:ph type="body" sz="quarter" idx="22"/>
          </p:nvPr>
        </p:nvSpPr>
        <p:spPr>
          <a:xfrm>
            <a:off x="377999" y="1547998"/>
            <a:ext cx="11440800" cy="4309200"/>
          </a:xfrm>
        </p:spPr>
        <p:txBody>
          <a:bodyPr lIns="0" tIns="0" rIns="0" bIns="0">
            <a:noAutofit/>
          </a:bodyPr>
          <a:lstStyle>
            <a:lvl1pPr hangingPunct="0">
              <a:lnSpc>
                <a:spcPts val="2200"/>
              </a:lnSpc>
              <a:defRPr sz="2000"/>
            </a:lvl1pPr>
            <a:lvl2pPr hangingPunct="0">
              <a:lnSpc>
                <a:spcPts val="2200"/>
              </a:lnSpc>
              <a:defRPr sz="2000"/>
            </a:lvl2pPr>
            <a:lvl3pPr hangingPunct="0">
              <a:lnSpc>
                <a:spcPts val="2200"/>
              </a:lnSpc>
              <a:defRPr sz="2000"/>
            </a:lvl3pPr>
            <a:lvl4pPr hangingPunct="0">
              <a:lnSpc>
                <a:spcPts val="2200"/>
              </a:lnSpc>
              <a:defRPr sz="2000"/>
            </a:lvl4pPr>
            <a:lvl5pPr hangingPunct="0">
              <a:lnSpc>
                <a:spcPts val="2200"/>
              </a:lnSpc>
              <a:defRPr sz="2000"/>
            </a:lvl5pPr>
          </a:lstStyle>
          <a:p>
            <a:pPr lvl="0"/>
            <a:r>
              <a:rPr lang="de-DE" dirty="0"/>
              <a:t>Mastertext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</p:spTree>
    <p:extLst>
      <p:ext uri="{BB962C8B-B14F-4D97-AF65-F5344CB8AC3E}">
        <p14:creationId xmlns:p14="http://schemas.microsoft.com/office/powerpoint/2010/main" val="1788766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0779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9417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725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7579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1940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3381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9320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2999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B625D-B01E-400B-8900-90578FA49AC3}" type="datetimeFigureOut">
              <a:rPr lang="de-DE" smtClean="0"/>
              <a:t>20.08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B038A6-6B07-4EB9-AB97-5D9E1137CE2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91342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3">
            <a:extLst>
              <a:ext uri="{FF2B5EF4-FFF2-40B4-BE49-F238E27FC236}">
                <a16:creationId xmlns:a16="http://schemas.microsoft.com/office/drawing/2014/main" id="{3E197F4A-C6F5-2C7F-9D97-9C8E70ED8537}"/>
              </a:ext>
            </a:extLst>
          </p:cNvPr>
          <p:cNvSpPr/>
          <p:nvPr/>
        </p:nvSpPr>
        <p:spPr>
          <a:xfrm>
            <a:off x="1486828" y="543370"/>
            <a:ext cx="6203686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August 2005 – January 2023</a:t>
            </a:r>
          </a:p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,001 patients with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,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R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,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L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, or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ositive MPN were diagnosed</a:t>
            </a:r>
          </a:p>
        </p:txBody>
      </p:sp>
      <p:sp>
        <p:nvSpPr>
          <p:cNvPr id="9" name="Rectangle 5">
            <a:extLst>
              <a:ext uri="{FF2B5EF4-FFF2-40B4-BE49-F238E27FC236}">
                <a16:creationId xmlns:a16="http://schemas.microsoft.com/office/drawing/2014/main" id="{AE2916F3-9448-DF02-9E71-D18675490BE9}"/>
              </a:ext>
            </a:extLst>
          </p:cNvPr>
          <p:cNvSpPr/>
          <p:nvPr/>
        </p:nvSpPr>
        <p:spPr>
          <a:xfrm>
            <a:off x="1486828" y="1494048"/>
            <a:ext cx="3085172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,105 patients with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R::ABL1-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itive MPN (CML)</a:t>
            </a:r>
          </a:p>
        </p:txBody>
      </p:sp>
      <p:sp>
        <p:nvSpPr>
          <p:cNvPr id="15" name="Rectangle 13">
            <a:extLst>
              <a:ext uri="{FF2B5EF4-FFF2-40B4-BE49-F238E27FC236}">
                <a16:creationId xmlns:a16="http://schemas.microsoft.com/office/drawing/2014/main" id="{194449F0-84C7-6076-EAFC-7D6119DB6D18}"/>
              </a:ext>
            </a:extLst>
          </p:cNvPr>
          <p:cNvSpPr/>
          <p:nvPr/>
        </p:nvSpPr>
        <p:spPr>
          <a:xfrm>
            <a:off x="1883932" y="2794470"/>
            <a:ext cx="2277204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37 patients tested for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R, 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L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utations</a:t>
            </a:r>
          </a:p>
        </p:txBody>
      </p:sp>
      <p:cxnSp>
        <p:nvCxnSpPr>
          <p:cNvPr id="3" name="Gerade Verbindung mit Pfeil 2"/>
          <p:cNvCxnSpPr>
            <a:cxnSpLocks/>
          </p:cNvCxnSpPr>
          <p:nvPr/>
        </p:nvCxnSpPr>
        <p:spPr>
          <a:xfrm flipH="1">
            <a:off x="3183520" y="1189998"/>
            <a:ext cx="485767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>
            <a:off x="5106473" y="1189998"/>
            <a:ext cx="481527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>
            <a:off x="3029414" y="2398091"/>
            <a:ext cx="0" cy="324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>
            <a:off x="6351037" y="2398091"/>
            <a:ext cx="0" cy="324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flipH="1">
            <a:off x="2335227" y="3446971"/>
            <a:ext cx="350540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>
            <a:cxnSpLocks/>
          </p:cNvCxnSpPr>
          <p:nvPr/>
        </p:nvCxnSpPr>
        <p:spPr>
          <a:xfrm>
            <a:off x="3335933" y="3446971"/>
            <a:ext cx="344736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/>
          <p:cNvCxnSpPr>
            <a:cxnSpLocks/>
          </p:cNvCxnSpPr>
          <p:nvPr/>
        </p:nvCxnSpPr>
        <p:spPr>
          <a:xfrm flipH="1">
            <a:off x="5647058" y="3446971"/>
            <a:ext cx="383400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>
            <a:cxnSpLocks/>
          </p:cNvCxnSpPr>
          <p:nvPr/>
        </p:nvCxnSpPr>
        <p:spPr>
          <a:xfrm>
            <a:off x="6618082" y="3446971"/>
            <a:ext cx="335311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4">
            <a:extLst>
              <a:ext uri="{FF2B5EF4-FFF2-40B4-BE49-F238E27FC236}">
                <a16:creationId xmlns:a16="http://schemas.microsoft.com/office/drawing/2014/main" id="{FE7217A5-44A8-B09B-7F17-F8E4D334E33C}"/>
              </a:ext>
            </a:extLst>
          </p:cNvPr>
          <p:cNvSpPr/>
          <p:nvPr/>
        </p:nvSpPr>
        <p:spPr>
          <a:xfrm>
            <a:off x="4605343" y="1494048"/>
            <a:ext cx="3085171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7,896 patients with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R::</a:t>
            </a:r>
            <a:r>
              <a:rPr lang="en-US" sz="900" b="1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L1-</a:t>
            </a:r>
            <a:r>
              <a:rPr lang="en-US" sz="9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gative MPN</a:t>
            </a:r>
            <a:endParaRPr lang="en-US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12">
            <a:extLst>
              <a:ext uri="{FF2B5EF4-FFF2-40B4-BE49-F238E27FC236}">
                <a16:creationId xmlns:a16="http://schemas.microsoft.com/office/drawing/2014/main" id="{AC1A37BC-7B19-2D7B-6F8A-66E4FB2D8D10}"/>
              </a:ext>
            </a:extLst>
          </p:cNvPr>
          <p:cNvSpPr/>
          <p:nvPr/>
        </p:nvSpPr>
        <p:spPr>
          <a:xfrm>
            <a:off x="5172885" y="2794469"/>
            <a:ext cx="2348095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53 patients tested for 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location</a:t>
            </a:r>
          </a:p>
        </p:txBody>
      </p:sp>
      <p:sp>
        <p:nvSpPr>
          <p:cNvPr id="34" name="Rectangle 14">
            <a:extLst>
              <a:ext uri="{FF2B5EF4-FFF2-40B4-BE49-F238E27FC236}">
                <a16:creationId xmlns:a16="http://schemas.microsoft.com/office/drawing/2014/main" id="{72232CE2-6AB7-9765-5873-C817FA336FD7}"/>
              </a:ext>
            </a:extLst>
          </p:cNvPr>
          <p:cNvSpPr/>
          <p:nvPr/>
        </p:nvSpPr>
        <p:spPr>
          <a:xfrm>
            <a:off x="6357477" y="3730350"/>
            <a:ext cx="1163505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 positive </a:t>
            </a:r>
          </a:p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PN + CML)</a:t>
            </a:r>
            <a:endParaRPr lang="en-US" sz="900" b="1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16">
            <a:extLst>
              <a:ext uri="{FF2B5EF4-FFF2-40B4-BE49-F238E27FC236}">
                <a16:creationId xmlns:a16="http://schemas.microsoft.com/office/drawing/2014/main" id="{82225C56-126B-D913-F2A6-C99E4E1A23E5}"/>
              </a:ext>
            </a:extLst>
          </p:cNvPr>
          <p:cNvSpPr/>
          <p:nvPr/>
        </p:nvSpPr>
        <p:spPr>
          <a:xfrm>
            <a:off x="5172885" y="3730350"/>
            <a:ext cx="1163505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98 negative</a:t>
            </a:r>
            <a:r>
              <a:rPr lang="en-US" sz="9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PN)</a:t>
            </a:r>
          </a:p>
        </p:txBody>
      </p:sp>
      <p:sp>
        <p:nvSpPr>
          <p:cNvPr id="22" name="TextBox 17">
            <a:extLst>
              <a:ext uri="{FF2B5EF4-FFF2-40B4-BE49-F238E27FC236}">
                <a16:creationId xmlns:a16="http://schemas.microsoft.com/office/drawing/2014/main" id="{C15D8964-E847-3718-0E9F-15C3F6B8EA76}"/>
              </a:ext>
            </a:extLst>
          </p:cNvPr>
          <p:cNvSpPr txBox="1"/>
          <p:nvPr/>
        </p:nvSpPr>
        <p:spPr>
          <a:xfrm>
            <a:off x="2447140" y="2183257"/>
            <a:ext cx="42883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tested due to changes in blood picture after excluding disease progression</a:t>
            </a:r>
          </a:p>
        </p:txBody>
      </p:sp>
      <p:sp>
        <p:nvSpPr>
          <p:cNvPr id="4" name="Rectangle 14">
            <a:extLst>
              <a:ext uri="{FF2B5EF4-FFF2-40B4-BE49-F238E27FC236}">
                <a16:creationId xmlns:a16="http://schemas.microsoft.com/office/drawing/2014/main" id="{55A4C52B-2CDA-5C86-9E51-D623CFAE0CDC}"/>
              </a:ext>
            </a:extLst>
          </p:cNvPr>
          <p:cNvSpPr/>
          <p:nvPr/>
        </p:nvSpPr>
        <p:spPr>
          <a:xfrm>
            <a:off x="2994843" y="3730350"/>
            <a:ext cx="1163505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9 positive </a:t>
            </a:r>
          </a:p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ML + MPN)</a:t>
            </a:r>
            <a:endParaRPr lang="en-US" sz="900" b="1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16">
            <a:extLst>
              <a:ext uri="{FF2B5EF4-FFF2-40B4-BE49-F238E27FC236}">
                <a16:creationId xmlns:a16="http://schemas.microsoft.com/office/drawing/2014/main" id="{8F540530-F9E9-40D1-F701-4E5CF971DBAC}"/>
              </a:ext>
            </a:extLst>
          </p:cNvPr>
          <p:cNvSpPr/>
          <p:nvPr/>
        </p:nvSpPr>
        <p:spPr>
          <a:xfrm>
            <a:off x="1810251" y="3730350"/>
            <a:ext cx="1163505" cy="576000"/>
          </a:xfrm>
          <a:prstGeom prst="rect">
            <a:avLst/>
          </a:prstGeom>
          <a:ln w="38100">
            <a:solidFill>
              <a:schemeClr val="tx1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18 negative (CML)</a:t>
            </a:r>
            <a:endParaRPr lang="en-US" sz="900" b="1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FC1CE7E1-34BB-E670-1A63-99EC2B57F9B6}"/>
              </a:ext>
            </a:extLst>
          </p:cNvPr>
          <p:cNvSpPr txBox="1"/>
          <p:nvPr/>
        </p:nvSpPr>
        <p:spPr>
          <a:xfrm>
            <a:off x="1486828" y="4920463"/>
            <a:ext cx="627922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Diagnostic algorithm for patients with CML+MPN or MPN+CML.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Between August 2005 and January 2023, 35,001 patients were diagnosed with an MPN. 7,105 patients had a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sitive CML and 27,896 had a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negative MPN (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utation: n=23,733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AL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utation: n=2,959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MP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utation: n=762, 2 or more mutations: n=442). Due to changes in the peripheral blood picture during the course of the disease and after excluding progression of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negative MPN and CML, 337 patients with CML were tested for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AL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MP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utations and 953 patients with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negative MPN were tested for the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anslocation. 19 patients with CML were positive for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AL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or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MP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mutations, consistent with CML+MPN. 55 patients with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negative MPN had a secondary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anslocation, corresponding to MPN+CML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9556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8850327"/>
              </p:ext>
            </p:extLst>
          </p:nvPr>
        </p:nvGraphicFramePr>
        <p:xfrm>
          <a:off x="997528" y="553412"/>
          <a:ext cx="8072583" cy="2438063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269086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69086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69086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05438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PN + CM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ormation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</a:t>
                      </a:r>
                      <a:r>
                        <a:rPr lang="de-DE" sz="9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::ABL1-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MPN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ou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ormation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</a:t>
                      </a:r>
                      <a:r>
                        <a:rPr lang="de-DE" sz="9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::ABL1-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MP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0375"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 (65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35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0375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reductive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69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0375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reductive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olitinib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1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0375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olitinib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o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3%)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0375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feron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3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0375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lebotomy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6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0375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8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2" name="Textfeld 1">
            <a:extLst>
              <a:ext uri="{FF2B5EF4-FFF2-40B4-BE49-F238E27FC236}">
                <a16:creationId xmlns:a16="http://schemas.microsoft.com/office/drawing/2014/main" id="{861AEF47-F43C-347A-A842-C6B4E24DB308}"/>
              </a:ext>
            </a:extLst>
          </p:cNvPr>
          <p:cNvSpPr txBox="1"/>
          <p:nvPr/>
        </p:nvSpPr>
        <p:spPr>
          <a:xfrm>
            <a:off x="912846" y="3105834"/>
            <a:ext cx="81572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Analysis of treatment of </a:t>
            </a:r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-negative MPN at the time of CML diagnosis.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Data on the treatment of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BCR::ABL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negative MPN were available for 36 patients. All patients were treated according to the guidelines: 25 received cytoreductive therapy (hydroxyurea, hydroxycarbamide, or anagrelide), 4 received combination of cytoreductive therapy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ruxolitini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1 receive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ruxolitini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1 received interferon, and 2 received phlebotomy. Only 3 patients were untreated. 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97173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188897" y="78958"/>
            <a:ext cx="15055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3A</a:t>
            </a:r>
          </a:p>
        </p:txBody>
      </p:sp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3632762"/>
              </p:ext>
            </p:extLst>
          </p:nvPr>
        </p:nvGraphicFramePr>
        <p:xfrm>
          <a:off x="180770" y="328860"/>
          <a:ext cx="11750880" cy="2486259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238285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6742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800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5990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ML + MP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ormation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CML and </a:t>
                      </a:r>
                      <a:r>
                        <a:rPr lang="de-DE" sz="9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::ABL1-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MPN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ou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ormation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CML and </a:t>
                      </a:r>
                      <a:r>
                        <a:rPr lang="de-DE" sz="9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::ABL1-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MP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1528"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(74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26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29401">
                <a:tc>
                  <a:txBody>
                    <a:bodyPr/>
                    <a:lstStyle/>
                    <a:p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I</a:t>
                      </a:r>
                    </a:p>
                    <a:p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lowed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="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ogeneic</a:t>
                      </a:r>
                      <a:r>
                        <a:rPr lang="de-DE" sz="900" baseline="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Tx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6%)</a:t>
                      </a:r>
                    </a:p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4159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reductive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TKI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29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1528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reductive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7%)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10597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feron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lowed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ciminib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1528">
                <a:tc>
                  <a:txBody>
                    <a:bodyPr/>
                    <a:lstStyle/>
                    <a:p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I +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olitinib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7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1528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apy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4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161142" y="3002071"/>
            <a:ext cx="15055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900" b="1" dirty="0">
                <a:latin typeface="Arial" panose="020B0604020202020204" pitchFamily="34" charset="0"/>
                <a:cs typeface="Arial" panose="020B0604020202020204" pitchFamily="34" charset="0"/>
              </a:rPr>
              <a:t> 3B</a:t>
            </a:r>
          </a:p>
        </p:txBody>
      </p:sp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6076799"/>
              </p:ext>
            </p:extLst>
          </p:nvPr>
        </p:nvGraphicFramePr>
        <p:xfrm>
          <a:off x="180770" y="3259097"/>
          <a:ext cx="11757230" cy="1563365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23909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72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942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9453"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PN + CM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ormation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</a:t>
                      </a:r>
                      <a:r>
                        <a:rPr lang="de-DE" sz="9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::ABL1-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MPN and CML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ou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ormation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ou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</a:t>
                      </a:r>
                      <a:r>
                        <a:rPr lang="de-DE" sz="9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::ABL1-</a:t>
                      </a:r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MPN and CM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1528"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 (76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24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29401">
                <a:tc>
                  <a:txBody>
                    <a:bodyPr/>
                    <a:lstStyle/>
                    <a:p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I</a:t>
                      </a:r>
                    </a:p>
                    <a:p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lowed</a:t>
                      </a:r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</a:t>
                      </a:r>
                      <a:r>
                        <a:rPr lang="de-DE" sz="9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ogeneic</a:t>
                      </a:r>
                      <a:r>
                        <a:rPr lang="de-DE" sz="9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Tx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 (88%)</a:t>
                      </a:r>
                    </a:p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7121">
                <a:tc>
                  <a:txBody>
                    <a:bodyPr/>
                    <a:lstStyle/>
                    <a:p>
                      <a:r>
                        <a:rPr lang="de-DE" sz="9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I + </a:t>
                      </a:r>
                      <a:r>
                        <a:rPr lang="de-DE" sz="9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xolitinib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0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5862">
                <a:tc>
                  <a:txBody>
                    <a:bodyPr/>
                    <a:lstStyle/>
                    <a:p>
                      <a:r>
                        <a:rPr lang="de-DE" sz="9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ogeneic</a:t>
                      </a:r>
                      <a:r>
                        <a:rPr lang="de-DE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Tx</a:t>
                      </a:r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2%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de-DE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" name="Textfeld 1">
            <a:extLst>
              <a:ext uri="{FF2B5EF4-FFF2-40B4-BE49-F238E27FC236}">
                <a16:creationId xmlns:a16="http://schemas.microsoft.com/office/drawing/2014/main" id="{8A6C67F5-4F0A-D05A-DEEB-3762AE0BEF02}"/>
              </a:ext>
            </a:extLst>
          </p:cNvPr>
          <p:cNvSpPr txBox="1"/>
          <p:nvPr/>
        </p:nvSpPr>
        <p:spPr>
          <a:xfrm>
            <a:off x="110920" y="4921934"/>
            <a:ext cx="11827080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3: Analysis of treatment of CML+MPN and MPN+CML.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, Data on the treatment of patients with CML+MPN were available for 14 cases. 5 patients were treated with tyrosine kinase inhibitor (TKI), 2 of whom received allogeneic stem cell transplantation (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Tx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during follow-up. 4 patients were treated with a combination of TKI and cytoreductive therapy (hydroxyurea, hydroxycarbamide, or anagrelide), 1 received only cytoreductive therapy. 1 patient was treated with interferon followed by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ciminib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1 received a TKI and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uxolitinib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and 2 received no therapy. B, Data on the treatment of patients with MPN+CML were available for 42 cases. 37 patients were treated with tyrosine kinase inhibitor (TKI), 1 of whom received allogeneic stem cell transplantation (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CTx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during follow-up. 4 patients were treated with TKI + </a:t>
            </a:r>
            <a:r>
              <a:rPr lang="en-US" sz="9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uxolitinib</a:t>
            </a:r>
            <a:r>
              <a:rPr lang="en-US" sz="9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1 patients received allogeneic stem cell transplantation after diagnosis of secondary CML.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9031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6</Words>
  <Application>Microsoft Office PowerPoint</Application>
  <PresentationFormat>Breitbild</PresentationFormat>
  <Paragraphs>70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Company>ML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trin Schweneker</dc:creator>
  <cp:lastModifiedBy>Katrin Schweneker</cp:lastModifiedBy>
  <cp:revision>160</cp:revision>
  <dcterms:created xsi:type="dcterms:W3CDTF">2023-11-14T14:06:31Z</dcterms:created>
  <dcterms:modified xsi:type="dcterms:W3CDTF">2025-08-20T09:01:23Z</dcterms:modified>
</cp:coreProperties>
</file>